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7" r:id="rId3"/>
    <p:sldId id="268" r:id="rId4"/>
    <p:sldId id="259" r:id="rId5"/>
    <p:sldId id="260" r:id="rId6"/>
    <p:sldId id="272" r:id="rId7"/>
    <p:sldId id="261" r:id="rId8"/>
    <p:sldId id="273" r:id="rId9"/>
    <p:sldId id="262" r:id="rId10"/>
    <p:sldId id="264" r:id="rId11"/>
    <p:sldId id="270" r:id="rId12"/>
    <p:sldId id="258" r:id="rId13"/>
    <p:sldId id="267" r:id="rId14"/>
    <p:sldId id="271" r:id="rId1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72" y="4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75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3B4AD6-378B-6221-AF4A-D94AC0E1E9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6A4554E-4FF2-3E05-D789-9332FC0525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A7EBDE-0545-2C48-AA20-6D23F0859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93A49F-CF63-3179-B91E-4C946B4CB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13EF8A-D27B-C430-E7F3-2E71FEAD2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7489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378D8A-3D5A-7582-D2DF-ABCE932E93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50700DE-9ADE-6EE2-CAD0-47E9F763C2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514FEC-21BC-1D24-1603-A2AA14CC2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3DC5E6-1A5D-0DC2-0950-BE58DFC13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4FDDA0-1AD7-8A9D-5AF5-99783AB42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4446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E27ACA2-8D85-7C07-6AA0-FFBBE8BC29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F76D65F-4A7E-E231-AE61-4E909D5156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4A0D10-844B-7E5D-F1C1-73F07DAB7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D8B436-01AB-A302-231D-E07788A83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A46CD0-4653-12C8-4532-015014A79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6136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34682E-B517-DEBF-F92E-7C6671306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9A264F9-9B01-E13D-31CD-0D0798FEF2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A00413-1DDB-8F15-3C4F-FC06EF5CB9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1C9859-0BF3-703C-8DEE-3C620CB55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AC52A1-5253-CB28-BC80-354DAF281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717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9D4146-83B6-45F9-A387-9C08ED6CE9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3A07ED5-BB79-D5B2-217A-C384386732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A6B5F4-4750-24CF-BDDC-6E1A462E7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CA27BE-D32A-D6EF-B5FE-49D5A766E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DC62E7-F2ED-96D9-D003-1613C45F6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4319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A62489-8C4C-80A5-D95C-FCBE71FCE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7A8F20D-0D93-B04C-EA22-C7C836CA67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209FD0-431A-26CC-752E-A5DD2D85C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117EA8-E6A7-203D-94C5-E41179A0C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D920858-433E-312F-6308-920744E7B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7F93BB-E749-C740-A77F-6BF9972FD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5861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6A6672-DDF2-3F06-EFD2-9E371571C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0FAD568-7C31-C84A-837E-BAE0F05DAA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968F732-E7F5-4417-68B5-3E759B5FE2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9CDDB55-5ADB-CA59-B135-2FAE608B55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508B761-AEC5-C4E1-E4F7-0DB5E712B5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118B05-090C-72B1-D7F1-2E39DD29A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01343FE-B1F1-7F7B-FFF1-11AAF44A0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7242546-7969-FEAF-FF61-1ED6F3AF8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6915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EAAAD6-07EE-C5D8-7EE3-E1A1B01EA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EA7485A-527B-43C3-9B30-183557F67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6646C04-BADB-3D42-1BE9-F1267AAB7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4067EA1-8471-A850-F7E1-929585FEC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319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4951071-91B0-0BA3-7F39-97178993B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33B69C4-3066-50FF-D66A-E969FB912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F5E0E8-9CF3-DCD2-B5D6-F27B8A770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4280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E5B0CB-993F-C643-ED01-374D3FFEB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3D0946E-42F3-40BB-E13D-064B7AC462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B84A71B-467C-198C-24DC-784E03D3C0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942B9E8-E6F5-1287-03FC-DD86B0523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16B6C8-A324-59C5-DE8D-D5CFB87DF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E5F8A59-40C6-3DCB-DC4F-EB2A04F55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1702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EA149A-7CDA-4532-BAC9-5ADD10984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AC6A1A8-0B7C-D9BB-0A96-02635511FD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9F4EE1A-720B-9413-0859-AEB8CD3563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63F886-B9EC-B278-EBFA-324894C97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B26119-0706-8C09-B7BC-9AF88A60B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F90903F-A150-13B6-FB7D-0E6B3DBDB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3709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E8DB5E4-3B29-B9AF-9BFB-0BB7553F3D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7E60330-FEEA-3972-41F2-ACB7228BDF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98A30E-6F55-6C61-AC61-BF1217B30E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A90E6-ECCD-4EAA-9A23-9DCCD63FFEB9}" type="datetimeFigureOut">
              <a:rPr lang="zh-CN" altLang="en-US" smtClean="0"/>
              <a:t>2025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27BF13-87DE-9906-B7FD-CF53D9DAAF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9E20E0-092F-7D62-1B91-68A49F60F5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9DC1A-5766-4575-8639-0EFC2C1009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331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ti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tif"/><Relationship Id="rId4" Type="http://schemas.openxmlformats.org/officeDocument/2006/relationships/image" Target="../media/image36.ti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"/><Relationship Id="rId2" Type="http://schemas.openxmlformats.org/officeDocument/2006/relationships/image" Target="../media/image38.ti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"/><Relationship Id="rId2" Type="http://schemas.openxmlformats.org/officeDocument/2006/relationships/image" Target="../media/image4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3.tif"/><Relationship Id="rId4" Type="http://schemas.openxmlformats.org/officeDocument/2006/relationships/image" Target="../media/image42.ti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"/><Relationship Id="rId4" Type="http://schemas.openxmlformats.org/officeDocument/2006/relationships/image" Target="../media/image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4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"/><Relationship Id="rId5" Type="http://schemas.openxmlformats.org/officeDocument/2006/relationships/image" Target="../media/image12.tif"/><Relationship Id="rId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tif"/><Relationship Id="rId4" Type="http://schemas.openxmlformats.org/officeDocument/2006/relationships/image" Target="../media/image25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tif"/><Relationship Id="rId4" Type="http://schemas.openxmlformats.org/officeDocument/2006/relationships/image" Target="../media/image2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02913C9-89DB-7701-6348-593C352C3054}"/>
              </a:ext>
            </a:extLst>
          </p:cNvPr>
          <p:cNvSpPr txBox="1"/>
          <p:nvPr/>
        </p:nvSpPr>
        <p:spPr>
          <a:xfrm>
            <a:off x="48861" y="53281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1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8F3B7DA-98DA-AAE8-9190-E1982CED34CB}"/>
              </a:ext>
            </a:extLst>
          </p:cNvPr>
          <p:cNvSpPr txBox="1"/>
          <p:nvPr/>
        </p:nvSpPr>
        <p:spPr>
          <a:xfrm>
            <a:off x="7093847" y="207300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5264D8B1-F3FD-9B6C-459F-1BFEF6C52E7C}"/>
              </a:ext>
            </a:extLst>
          </p:cNvPr>
          <p:cNvSpPr txBox="1"/>
          <p:nvPr/>
        </p:nvSpPr>
        <p:spPr>
          <a:xfrm>
            <a:off x="4182617" y="2199744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AED8647-E159-C0D8-D34B-CA55F5AD5D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444" y="1004711"/>
            <a:ext cx="2039112" cy="1728216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8158434F-A61A-5572-5880-0CEE38343853}"/>
              </a:ext>
            </a:extLst>
          </p:cNvPr>
          <p:cNvSpPr/>
          <p:nvPr/>
        </p:nvSpPr>
        <p:spPr>
          <a:xfrm>
            <a:off x="5554656" y="2278440"/>
            <a:ext cx="1290320" cy="338554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68AC494-91B2-E018-6CE6-4BE33BD78CD0}"/>
              </a:ext>
            </a:extLst>
          </p:cNvPr>
          <p:cNvSpPr txBox="1"/>
          <p:nvPr/>
        </p:nvSpPr>
        <p:spPr>
          <a:xfrm>
            <a:off x="2606729" y="3782341"/>
            <a:ext cx="1296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ED47A78-EBE5-2765-1B90-31128414E528}"/>
              </a:ext>
            </a:extLst>
          </p:cNvPr>
          <p:cNvSpPr txBox="1"/>
          <p:nvPr/>
        </p:nvSpPr>
        <p:spPr>
          <a:xfrm>
            <a:off x="7822354" y="3720153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2FC51E8-FDE3-A906-0E73-96762D92B4F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6579" y="3585464"/>
            <a:ext cx="4023360" cy="1901952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53A32167-650A-3910-CB25-AA12745503A4}"/>
              </a:ext>
            </a:extLst>
          </p:cNvPr>
          <p:cNvSpPr/>
          <p:nvPr/>
        </p:nvSpPr>
        <p:spPr>
          <a:xfrm>
            <a:off x="4091012" y="3720153"/>
            <a:ext cx="1296360" cy="4315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24570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861" y="53281"/>
            <a:ext cx="2782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8C, 8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DE80BE7-CD0D-2760-7AFB-77BACDFBF4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8208" y="1834292"/>
            <a:ext cx="5084064" cy="161848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53B7ED7-5E22-8B8D-167A-ACC7D1B8DBB1}"/>
              </a:ext>
            </a:extLst>
          </p:cNvPr>
          <p:cNvSpPr txBox="1"/>
          <p:nvPr/>
        </p:nvSpPr>
        <p:spPr>
          <a:xfrm>
            <a:off x="2124802" y="2401904"/>
            <a:ext cx="15966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ytoplasmic-SG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CBF2EBE-D0B6-4E2F-C2C6-30A887FC1329}"/>
              </a:ext>
            </a:extLst>
          </p:cNvPr>
          <p:cNvSpPr txBox="1"/>
          <p:nvPr/>
        </p:nvSpPr>
        <p:spPr>
          <a:xfrm>
            <a:off x="7876598" y="2474259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23E5F102-64E1-A6CA-6907-F09F4716F6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932" y="253336"/>
            <a:ext cx="5660136" cy="1252728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943791DC-93F6-2890-BD40-E5FAF947BD53}"/>
              </a:ext>
            </a:extLst>
          </p:cNvPr>
          <p:cNvSpPr txBox="1"/>
          <p:nvPr/>
        </p:nvSpPr>
        <p:spPr>
          <a:xfrm>
            <a:off x="8926068" y="82734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6F20A60-6A08-B063-C0AA-C4DE78BE4D09}"/>
              </a:ext>
            </a:extLst>
          </p:cNvPr>
          <p:cNvSpPr txBox="1"/>
          <p:nvPr/>
        </p:nvSpPr>
        <p:spPr>
          <a:xfrm>
            <a:off x="2151968" y="673452"/>
            <a:ext cx="11139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ucleus-NRF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D9E59182-73AD-9284-2C89-D2D47A0642C3}"/>
              </a:ext>
            </a:extLst>
          </p:cNvPr>
          <p:cNvSpPr/>
          <p:nvPr/>
        </p:nvSpPr>
        <p:spPr>
          <a:xfrm>
            <a:off x="5101405" y="755542"/>
            <a:ext cx="1268915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431FE6D-D53A-5DB8-D4F7-FF6DD099C42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10133">
            <a:off x="3574012" y="3702679"/>
            <a:ext cx="3858768" cy="215798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032CE07-E20D-45A2-187D-F995B5BA2E34}"/>
              </a:ext>
            </a:extLst>
          </p:cNvPr>
          <p:cNvSpPr txBox="1"/>
          <p:nvPr/>
        </p:nvSpPr>
        <p:spPr>
          <a:xfrm>
            <a:off x="7876800" y="4589413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53BDB56-57DC-4F56-C8CE-C00E0522AA6C}"/>
              </a:ext>
            </a:extLst>
          </p:cNvPr>
          <p:cNvSpPr txBox="1"/>
          <p:nvPr/>
        </p:nvSpPr>
        <p:spPr>
          <a:xfrm>
            <a:off x="2157183" y="4503134"/>
            <a:ext cx="17030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</a:p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HO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24">
            <a:extLst>
              <a:ext uri="{FF2B5EF4-FFF2-40B4-BE49-F238E27FC236}">
                <a16:creationId xmlns:a16="http://schemas.microsoft.com/office/drawing/2014/main" id="{5FDFCA0C-0F08-406B-8BFE-E83382A930A6}"/>
              </a:ext>
            </a:extLst>
          </p:cNvPr>
          <p:cNvSpPr/>
          <p:nvPr/>
        </p:nvSpPr>
        <p:spPr>
          <a:xfrm>
            <a:off x="5095782" y="2330708"/>
            <a:ext cx="1268915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24">
            <a:extLst>
              <a:ext uri="{FF2B5EF4-FFF2-40B4-BE49-F238E27FC236}">
                <a16:creationId xmlns:a16="http://schemas.microsoft.com/office/drawing/2014/main" id="{4CD379BD-446B-4F57-B842-A2087E10045B}"/>
              </a:ext>
            </a:extLst>
          </p:cNvPr>
          <p:cNvSpPr/>
          <p:nvPr/>
        </p:nvSpPr>
        <p:spPr>
          <a:xfrm>
            <a:off x="5503396" y="4564380"/>
            <a:ext cx="1268915" cy="3886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14230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2CB2E31-3EAF-9C00-6791-F0C7254EB46C}"/>
              </a:ext>
            </a:extLst>
          </p:cNvPr>
          <p:cNvSpPr txBox="1"/>
          <p:nvPr/>
        </p:nvSpPr>
        <p:spPr>
          <a:xfrm>
            <a:off x="48861" y="53281"/>
            <a:ext cx="278282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8C, 8D (continued) 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0B46B6E-31F1-56DC-276E-4EC374F23F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91495">
            <a:off x="1849436" y="849516"/>
            <a:ext cx="4508500" cy="1499669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AB137CD0-E4C1-3E0A-E689-1FD345C91C96}"/>
              </a:ext>
            </a:extLst>
          </p:cNvPr>
          <p:cNvSpPr/>
          <p:nvPr/>
        </p:nvSpPr>
        <p:spPr>
          <a:xfrm>
            <a:off x="2731687" y="1363365"/>
            <a:ext cx="1371999" cy="373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67AFCAB5-1168-DFB0-A1D2-06F2CB497789}"/>
              </a:ext>
            </a:extLst>
          </p:cNvPr>
          <p:cNvSpPr/>
          <p:nvPr/>
        </p:nvSpPr>
        <p:spPr>
          <a:xfrm>
            <a:off x="4437242" y="1348126"/>
            <a:ext cx="1371999" cy="3892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A37EF5D-E682-6D5B-10DD-A576CD115329}"/>
              </a:ext>
            </a:extLst>
          </p:cNvPr>
          <p:cNvSpPr txBox="1"/>
          <p:nvPr/>
        </p:nvSpPr>
        <p:spPr>
          <a:xfrm>
            <a:off x="6260400" y="1276184"/>
            <a:ext cx="1147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ucleus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iston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F37F51E-8652-1B90-AFDD-4870F043EB87}"/>
              </a:ext>
            </a:extLst>
          </p:cNvPr>
          <p:cNvSpPr txBox="1"/>
          <p:nvPr/>
        </p:nvSpPr>
        <p:spPr>
          <a:xfrm>
            <a:off x="273600" y="1202381"/>
            <a:ext cx="17119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ytoplasmic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iston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14B769D0-EEC9-EC5F-BE56-5793A880BD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831" y="2653550"/>
            <a:ext cx="4690323" cy="922995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7EAFEC4-000A-12EA-D892-854277530CC9}"/>
              </a:ext>
            </a:extLst>
          </p:cNvPr>
          <p:cNvSpPr txBox="1"/>
          <p:nvPr/>
        </p:nvSpPr>
        <p:spPr>
          <a:xfrm>
            <a:off x="6260400" y="2898870"/>
            <a:ext cx="1147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ucleus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6FCA72A-6BA0-11AC-66CB-D10DCE7FA2D5}"/>
              </a:ext>
            </a:extLst>
          </p:cNvPr>
          <p:cNvSpPr txBox="1"/>
          <p:nvPr/>
        </p:nvSpPr>
        <p:spPr>
          <a:xfrm>
            <a:off x="273600" y="2776872"/>
            <a:ext cx="16017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ytoplasmic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1016578" y="300635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D86757ED-FC1A-1F19-2618-24E7F7DC1BB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79218" y="2249646"/>
            <a:ext cx="1737360" cy="129844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FAF43EC6-3B48-92F1-6449-A14F7654569E}"/>
              </a:ext>
            </a:extLst>
          </p:cNvPr>
          <p:cNvSpPr txBox="1"/>
          <p:nvPr/>
        </p:nvSpPr>
        <p:spPr>
          <a:xfrm>
            <a:off x="7932224" y="2796356"/>
            <a:ext cx="16537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ytoplasmic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D2936DD8-AA14-9BE1-7FC7-9A5B58CE042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1445" y="3975781"/>
            <a:ext cx="4734523" cy="1895794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1C740998-622D-187E-7320-DFD9CDDD5D5F}"/>
              </a:ext>
            </a:extLst>
          </p:cNvPr>
          <p:cNvSpPr txBox="1"/>
          <p:nvPr/>
        </p:nvSpPr>
        <p:spPr>
          <a:xfrm>
            <a:off x="6260400" y="4935990"/>
            <a:ext cx="1147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ucleus-Lamin 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B315DA1-CD5F-4684-6433-2E9C5B0B0CCD}"/>
              </a:ext>
            </a:extLst>
          </p:cNvPr>
          <p:cNvSpPr txBox="1"/>
          <p:nvPr/>
        </p:nvSpPr>
        <p:spPr>
          <a:xfrm>
            <a:off x="273600" y="4935990"/>
            <a:ext cx="17119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ytoplasmic-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amin 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7">
            <a:extLst>
              <a:ext uri="{FF2B5EF4-FFF2-40B4-BE49-F238E27FC236}">
                <a16:creationId xmlns:a16="http://schemas.microsoft.com/office/drawing/2014/main" id="{B089D5CD-0C47-49C6-8B25-6AF17D6E19F3}"/>
              </a:ext>
            </a:extLst>
          </p:cNvPr>
          <p:cNvSpPr/>
          <p:nvPr/>
        </p:nvSpPr>
        <p:spPr>
          <a:xfrm>
            <a:off x="4422002" y="2955946"/>
            <a:ext cx="1371999" cy="3892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7">
            <a:extLst>
              <a:ext uri="{FF2B5EF4-FFF2-40B4-BE49-F238E27FC236}">
                <a16:creationId xmlns:a16="http://schemas.microsoft.com/office/drawing/2014/main" id="{3E1AD05D-A408-4D8F-BDC7-D4BBA589BBA4}"/>
              </a:ext>
            </a:extLst>
          </p:cNvPr>
          <p:cNvSpPr/>
          <p:nvPr/>
        </p:nvSpPr>
        <p:spPr>
          <a:xfrm>
            <a:off x="4429622" y="5059066"/>
            <a:ext cx="1371999" cy="3892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7">
            <a:extLst>
              <a:ext uri="{FF2B5EF4-FFF2-40B4-BE49-F238E27FC236}">
                <a16:creationId xmlns:a16="http://schemas.microsoft.com/office/drawing/2014/main" id="{A85517D5-0BD0-4994-A51C-31301E421D11}"/>
              </a:ext>
            </a:extLst>
          </p:cNvPr>
          <p:cNvSpPr/>
          <p:nvPr/>
        </p:nvSpPr>
        <p:spPr>
          <a:xfrm>
            <a:off x="9405482" y="2948326"/>
            <a:ext cx="1371999" cy="38923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7734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861" y="53281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896400" y="3801195"/>
            <a:ext cx="1640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074000" y="1211013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855ACCA-6287-29FF-391F-DC63182D48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314"/>
          <a:stretch/>
        </p:blipFill>
        <p:spPr>
          <a:xfrm>
            <a:off x="1568985" y="921682"/>
            <a:ext cx="5349240" cy="100861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5BFE98F-ECC1-D8CD-0726-71312F9175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29874">
            <a:off x="1808019" y="2289423"/>
            <a:ext cx="5266944" cy="3026664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7A9FD318-A284-73A2-1367-A83922A36BBF}"/>
              </a:ext>
            </a:extLst>
          </p:cNvPr>
          <p:cNvSpPr txBox="1"/>
          <p:nvPr/>
        </p:nvSpPr>
        <p:spPr>
          <a:xfrm>
            <a:off x="7074000" y="3688404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7C158F94-9862-BCB0-98C7-97049B1AADB6}"/>
              </a:ext>
            </a:extLst>
          </p:cNvPr>
          <p:cNvSpPr/>
          <p:nvPr/>
        </p:nvSpPr>
        <p:spPr>
          <a:xfrm>
            <a:off x="2006700" y="1046481"/>
            <a:ext cx="4576980" cy="8068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93286969-D910-9C0A-400B-8B2E79DBA729}"/>
              </a:ext>
            </a:extLst>
          </p:cNvPr>
          <p:cNvSpPr/>
          <p:nvPr/>
        </p:nvSpPr>
        <p:spPr>
          <a:xfrm>
            <a:off x="2201443" y="3712217"/>
            <a:ext cx="4522838" cy="65876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96400" y="1364901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54897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861" y="53281"/>
            <a:ext cx="2782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9072540" y="5217521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43791DC-93F6-2890-BD40-E5FAF947BD53}"/>
              </a:ext>
            </a:extLst>
          </p:cNvPr>
          <p:cNvSpPr txBox="1"/>
          <p:nvPr/>
        </p:nvSpPr>
        <p:spPr>
          <a:xfrm>
            <a:off x="9072540" y="1030375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716A142-F1B4-4271-88AE-27BB3DF81A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491" y="1640479"/>
            <a:ext cx="6048077" cy="184071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B245A91-DC6F-5CC9-0B1E-AA88B6D74C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3595" y="3406105"/>
            <a:ext cx="5936827" cy="123118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8FD9674-9953-13AA-2DCC-7893C37B38D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4359" y="4661920"/>
            <a:ext cx="6220013" cy="2123907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611EA350-1D83-CBD4-CDA0-C2BAB2D075C9}"/>
              </a:ext>
            </a:extLst>
          </p:cNvPr>
          <p:cNvSpPr txBox="1"/>
          <p:nvPr/>
        </p:nvSpPr>
        <p:spPr>
          <a:xfrm>
            <a:off x="9072540" y="401760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8A4DDC6-8B3F-D3F7-0B38-96ABA277F494}"/>
              </a:ext>
            </a:extLst>
          </p:cNvPr>
          <p:cNvSpPr txBox="1"/>
          <p:nvPr/>
        </p:nvSpPr>
        <p:spPr>
          <a:xfrm>
            <a:off x="9071633" y="2986643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69BE93A3-E997-B657-2BA8-31BE30A8873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4187" y="256354"/>
            <a:ext cx="6105046" cy="1435258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0EB4968F-5A0A-C332-87BA-0D1840CCE364}"/>
              </a:ext>
            </a:extLst>
          </p:cNvPr>
          <p:cNvSpPr/>
          <p:nvPr/>
        </p:nvSpPr>
        <p:spPr>
          <a:xfrm>
            <a:off x="4989600" y="872652"/>
            <a:ext cx="3190567" cy="64151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3B73B90-2EED-75BB-F6DA-970483F3E682}"/>
              </a:ext>
            </a:extLst>
          </p:cNvPr>
          <p:cNvSpPr/>
          <p:nvPr/>
        </p:nvSpPr>
        <p:spPr>
          <a:xfrm>
            <a:off x="4987659" y="2739962"/>
            <a:ext cx="3189600" cy="58523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F22EB7EF-167C-E072-07C1-5DC692809733}"/>
              </a:ext>
            </a:extLst>
          </p:cNvPr>
          <p:cNvSpPr/>
          <p:nvPr/>
        </p:nvSpPr>
        <p:spPr>
          <a:xfrm>
            <a:off x="4989600" y="3795651"/>
            <a:ext cx="3189600" cy="64151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D8D1DC7F-0560-6E4C-5E21-5B8E62C95FCF}"/>
              </a:ext>
            </a:extLst>
          </p:cNvPr>
          <p:cNvSpPr/>
          <p:nvPr/>
        </p:nvSpPr>
        <p:spPr>
          <a:xfrm>
            <a:off x="4989600" y="5095971"/>
            <a:ext cx="3189600" cy="72989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A78563A-FFB2-9265-0F33-84B8116A8DFD}"/>
              </a:ext>
            </a:extLst>
          </p:cNvPr>
          <p:cNvSpPr txBox="1"/>
          <p:nvPr/>
        </p:nvSpPr>
        <p:spPr>
          <a:xfrm>
            <a:off x="2031540" y="5412871"/>
            <a:ext cx="1134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53B7ED7-5E22-8B8D-167A-ACC7D1B8DBB1}"/>
              </a:ext>
            </a:extLst>
          </p:cNvPr>
          <p:cNvSpPr txBox="1"/>
          <p:nvPr/>
        </p:nvSpPr>
        <p:spPr>
          <a:xfrm>
            <a:off x="2031540" y="3914331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SGK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0BE2EAA-D499-AAD9-76EB-72A100E5BD4F}"/>
              </a:ext>
            </a:extLst>
          </p:cNvPr>
          <p:cNvSpPr txBox="1"/>
          <p:nvPr/>
        </p:nvSpPr>
        <p:spPr>
          <a:xfrm>
            <a:off x="2031540" y="2862285"/>
            <a:ext cx="1173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R-tota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25">
            <a:extLst>
              <a:ext uri="{FF2B5EF4-FFF2-40B4-BE49-F238E27FC236}">
                <a16:creationId xmlns:a16="http://schemas.microsoft.com/office/drawing/2014/main" id="{1504E89C-2E99-40C1-9FBA-FABF44C5D806}"/>
              </a:ext>
            </a:extLst>
          </p:cNvPr>
          <p:cNvSpPr txBox="1"/>
          <p:nvPr/>
        </p:nvSpPr>
        <p:spPr>
          <a:xfrm>
            <a:off x="2031540" y="1025644"/>
            <a:ext cx="1173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R-</a:t>
            </a:r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433053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9A939A0-61E1-5C67-B6F7-A9B28B6B1268}"/>
              </a:ext>
            </a:extLst>
          </p:cNvPr>
          <p:cNvSpPr txBox="1"/>
          <p:nvPr/>
        </p:nvSpPr>
        <p:spPr>
          <a:xfrm>
            <a:off x="48861" y="53281"/>
            <a:ext cx="2782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S9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2B25D3B-EF95-3681-35C3-D9F95E6F9A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5990" y="398381"/>
            <a:ext cx="2011680" cy="263347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12B8450-AC4A-EC38-5917-C664FB18EE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0593" y="3157930"/>
            <a:ext cx="3689604" cy="2857298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053720D-5960-9A62-1E67-1107D62B1ECA}"/>
              </a:ext>
            </a:extLst>
          </p:cNvPr>
          <p:cNvSpPr txBox="1"/>
          <p:nvPr/>
        </p:nvSpPr>
        <p:spPr>
          <a:xfrm>
            <a:off x="7497670" y="1121246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F4ACEF1-7786-0A3E-1245-1FA9850F49CE}"/>
              </a:ext>
            </a:extLst>
          </p:cNvPr>
          <p:cNvSpPr txBox="1"/>
          <p:nvPr/>
        </p:nvSpPr>
        <p:spPr>
          <a:xfrm>
            <a:off x="4724495" y="1244356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SGK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D7AE566-EB45-8E92-D2F8-055F66C0E32A}"/>
              </a:ext>
            </a:extLst>
          </p:cNvPr>
          <p:cNvSpPr txBox="1"/>
          <p:nvPr/>
        </p:nvSpPr>
        <p:spPr>
          <a:xfrm>
            <a:off x="9130197" y="4041194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2189C8B-88B6-66C8-7C0A-0864CAC1CF00}"/>
              </a:ext>
            </a:extLst>
          </p:cNvPr>
          <p:cNvSpPr txBox="1"/>
          <p:nvPr/>
        </p:nvSpPr>
        <p:spPr>
          <a:xfrm>
            <a:off x="4456557" y="4133126"/>
            <a:ext cx="1322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A36BC1A-CA14-5713-0D0D-D35A05310D13}"/>
              </a:ext>
            </a:extLst>
          </p:cNvPr>
          <p:cNvSpPr/>
          <p:nvPr/>
        </p:nvSpPr>
        <p:spPr>
          <a:xfrm>
            <a:off x="5992846" y="1023909"/>
            <a:ext cx="1292549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3FCDB298-F8BF-6C2E-6D50-6E98A9056EC2}"/>
              </a:ext>
            </a:extLst>
          </p:cNvPr>
          <p:cNvSpPr/>
          <p:nvPr/>
        </p:nvSpPr>
        <p:spPr>
          <a:xfrm>
            <a:off x="5894237" y="4000008"/>
            <a:ext cx="1391158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8491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861" y="53281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2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762550" y="4131932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225253" y="86868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762550" y="3794311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AE6DDB5A-2FF8-1F38-9CC3-F17DFB7EAB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3533" y="300020"/>
            <a:ext cx="2331720" cy="1883664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90FA97A5-A73C-FCA6-D188-3A0D130EE57C}"/>
              </a:ext>
            </a:extLst>
          </p:cNvPr>
          <p:cNvSpPr txBox="1"/>
          <p:nvPr/>
        </p:nvSpPr>
        <p:spPr>
          <a:xfrm>
            <a:off x="6750188" y="610909"/>
            <a:ext cx="129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leaved-Caspas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C8139777-4AC4-F022-F0EB-A20FD54200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661" y="1131178"/>
            <a:ext cx="3675888" cy="1572768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70946" y="1747620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p-MLK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244228" y="1610669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EA39C01E-32B4-D600-30F5-35BC6E457E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347" y="3186348"/>
            <a:ext cx="4119983" cy="1502699"/>
          </a:xfrm>
          <a:prstGeom prst="rect">
            <a:avLst/>
          </a:prstGeom>
        </p:spPr>
      </p:pic>
      <p:sp>
        <p:nvSpPr>
          <p:cNvPr id="34" name="文本框 33"/>
          <p:cNvSpPr txBox="1"/>
          <p:nvPr/>
        </p:nvSpPr>
        <p:spPr>
          <a:xfrm>
            <a:off x="65344" y="3947266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37C2607-FFDB-C77A-2F7E-091E31122D03}"/>
              </a:ext>
            </a:extLst>
          </p:cNvPr>
          <p:cNvSpPr txBox="1"/>
          <p:nvPr/>
        </p:nvSpPr>
        <p:spPr>
          <a:xfrm>
            <a:off x="6102008" y="3962100"/>
            <a:ext cx="129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leaved-GSDM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3D32F95-031C-4651-AC82-BCAE16E78613}"/>
              </a:ext>
            </a:extLst>
          </p:cNvPr>
          <p:cNvSpPr txBox="1"/>
          <p:nvPr/>
        </p:nvSpPr>
        <p:spPr>
          <a:xfrm>
            <a:off x="11209289" y="423934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2ABF7C5F-7F30-9094-FB61-C96DEC5E1E7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3361" y="2748778"/>
            <a:ext cx="3995928" cy="2048256"/>
          </a:xfrm>
          <a:prstGeom prst="rect">
            <a:avLst/>
          </a:prstGeom>
        </p:spPr>
      </p:pic>
      <p:sp>
        <p:nvSpPr>
          <p:cNvPr id="56" name="文本框 55">
            <a:extLst>
              <a:ext uri="{FF2B5EF4-FFF2-40B4-BE49-F238E27FC236}">
                <a16:creationId xmlns:a16="http://schemas.microsoft.com/office/drawing/2014/main" id="{4F7932F1-D7FE-A656-DA88-392A91D1B64F}"/>
              </a:ext>
            </a:extLst>
          </p:cNvPr>
          <p:cNvSpPr txBox="1"/>
          <p:nvPr/>
        </p:nvSpPr>
        <p:spPr>
          <a:xfrm>
            <a:off x="11209289" y="3502254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55BE7AA-A668-5FC8-6C5F-495C4EF2C0CC}"/>
              </a:ext>
            </a:extLst>
          </p:cNvPr>
          <p:cNvSpPr txBox="1"/>
          <p:nvPr/>
        </p:nvSpPr>
        <p:spPr>
          <a:xfrm>
            <a:off x="6102008" y="3424268"/>
            <a:ext cx="1296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4E4CB430-CA44-0C1C-E6BD-1CB9A7FE4EE3}"/>
              </a:ext>
            </a:extLst>
          </p:cNvPr>
          <p:cNvSpPr/>
          <p:nvPr/>
        </p:nvSpPr>
        <p:spPr>
          <a:xfrm>
            <a:off x="1091700" y="1490480"/>
            <a:ext cx="1543149" cy="8595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96E8E5C4-244C-7364-8957-CC006759D750}"/>
              </a:ext>
            </a:extLst>
          </p:cNvPr>
          <p:cNvSpPr/>
          <p:nvPr/>
        </p:nvSpPr>
        <p:spPr>
          <a:xfrm>
            <a:off x="2943516" y="4077160"/>
            <a:ext cx="1406013" cy="462499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0CADC062-AF1F-4DEA-DEAB-1A5503440C2B}"/>
              </a:ext>
            </a:extLst>
          </p:cNvPr>
          <p:cNvSpPr/>
          <p:nvPr/>
        </p:nvSpPr>
        <p:spPr>
          <a:xfrm>
            <a:off x="8219768" y="610909"/>
            <a:ext cx="1496224" cy="854097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35C8C4D7-9D66-523E-0DEA-D04B358880DC}"/>
              </a:ext>
            </a:extLst>
          </p:cNvPr>
          <p:cNvSpPr/>
          <p:nvPr/>
        </p:nvSpPr>
        <p:spPr>
          <a:xfrm>
            <a:off x="7893533" y="3429000"/>
            <a:ext cx="1296360" cy="114889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22053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1B2112B-3C1B-3E9C-4174-1CDDB0AA85FA}"/>
              </a:ext>
            </a:extLst>
          </p:cNvPr>
          <p:cNvSpPr txBox="1"/>
          <p:nvPr/>
        </p:nvSpPr>
        <p:spPr>
          <a:xfrm>
            <a:off x="48861" y="53281"/>
            <a:ext cx="2782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2C (continued)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094429" y="85571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772400" y="85571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99FD476C-3914-A42D-2E1D-0C5F2426A5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8869" y="453391"/>
            <a:ext cx="3694176" cy="1362456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7772940" y="266757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8D49D52-A6D2-1511-0BA3-23AC903483C8}"/>
              </a:ext>
            </a:extLst>
          </p:cNvPr>
          <p:cNvSpPr txBox="1"/>
          <p:nvPr/>
        </p:nvSpPr>
        <p:spPr>
          <a:xfrm>
            <a:off x="3094429" y="266757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X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7C51136-03CA-EB41-5FE5-BF6EB18C09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8869" y="2151055"/>
            <a:ext cx="3995928" cy="1371600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182D85E5-1D2D-562C-C237-F3638D420AF5}"/>
              </a:ext>
            </a:extLst>
          </p:cNvPr>
          <p:cNvSpPr/>
          <p:nvPr/>
        </p:nvSpPr>
        <p:spPr>
          <a:xfrm>
            <a:off x="4178710" y="648929"/>
            <a:ext cx="1524000" cy="9045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DFBB763-ED88-43C0-88AC-C9DBCF72BB95}"/>
              </a:ext>
            </a:extLst>
          </p:cNvPr>
          <p:cNvSpPr/>
          <p:nvPr/>
        </p:nvSpPr>
        <p:spPr>
          <a:xfrm>
            <a:off x="4513006" y="2566219"/>
            <a:ext cx="1386349" cy="5997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18366A3F-18B8-893B-5832-D41768BA205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5184" y="3745484"/>
            <a:ext cx="2221992" cy="2313432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3F31165C-6417-B8E1-63E2-1558B6348774}"/>
              </a:ext>
            </a:extLst>
          </p:cNvPr>
          <p:cNvSpPr/>
          <p:nvPr/>
        </p:nvSpPr>
        <p:spPr>
          <a:xfrm>
            <a:off x="4604446" y="4821739"/>
            <a:ext cx="1386349" cy="5997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BD92F96-D7FB-499E-02D5-0A215710BA84}"/>
              </a:ext>
            </a:extLst>
          </p:cNvPr>
          <p:cNvSpPr txBox="1"/>
          <p:nvPr/>
        </p:nvSpPr>
        <p:spPr>
          <a:xfrm>
            <a:off x="3096000" y="4936957"/>
            <a:ext cx="1296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1279644-41F1-FA0A-5FD6-BF709974B548}"/>
              </a:ext>
            </a:extLst>
          </p:cNvPr>
          <p:cNvSpPr txBox="1"/>
          <p:nvPr/>
        </p:nvSpPr>
        <p:spPr>
          <a:xfrm>
            <a:off x="6201207" y="4936957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9829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861" y="53281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4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917226" y="2646858"/>
            <a:ext cx="12971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690958" y="2590196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690958" y="162129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792000" y="3066570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8142F1C-0610-4B4E-C314-CA7C1FA68EA5}"/>
              </a:ext>
            </a:extLst>
          </p:cNvPr>
          <p:cNvSpPr txBox="1"/>
          <p:nvPr/>
        </p:nvSpPr>
        <p:spPr>
          <a:xfrm>
            <a:off x="4881600" y="2868003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A9FD318-A284-73A2-1367-A83922A36BBF}"/>
              </a:ext>
            </a:extLst>
          </p:cNvPr>
          <p:cNvSpPr txBox="1"/>
          <p:nvPr/>
        </p:nvSpPr>
        <p:spPr>
          <a:xfrm>
            <a:off x="4881600" y="4792175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FD47412-4262-506D-00AA-5CFF722C44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42274">
            <a:off x="1775033" y="3809195"/>
            <a:ext cx="3163824" cy="196596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C9869A4-C3E3-42E3-0EC5-B6D276793CAA}"/>
              </a:ext>
            </a:extLst>
          </p:cNvPr>
          <p:cNvSpPr txBox="1"/>
          <p:nvPr/>
        </p:nvSpPr>
        <p:spPr>
          <a:xfrm>
            <a:off x="790997" y="4469009"/>
            <a:ext cx="129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leaved-Caspas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640406E-3A0B-FFFE-184B-6CCA563C61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8996" y="1632741"/>
            <a:ext cx="2663559" cy="228451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6B8B6C8-7F8C-BE0D-4A49-A0540478439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4870" y="766444"/>
            <a:ext cx="3091952" cy="1376355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F156DF7-62BC-7D49-31ED-A06A234220F1}"/>
              </a:ext>
            </a:extLst>
          </p:cNvPr>
          <p:cNvSpPr txBox="1"/>
          <p:nvPr/>
        </p:nvSpPr>
        <p:spPr>
          <a:xfrm>
            <a:off x="6916920" y="1605909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SGK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7F3A34E5-1289-8714-B6F5-5E92A6FCCA0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9971" y="2389903"/>
            <a:ext cx="2942690" cy="987829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618FBB7-4BA2-DFF0-8214-0C2A126092D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6667" y="1023083"/>
            <a:ext cx="3169493" cy="1008035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A04317A6-1F39-40B4-9B5E-1EB6B206D6D0}"/>
              </a:ext>
            </a:extLst>
          </p:cNvPr>
          <p:cNvSpPr txBox="1"/>
          <p:nvPr/>
        </p:nvSpPr>
        <p:spPr>
          <a:xfrm>
            <a:off x="4881600" y="1294187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A0079F5-3D4E-8BE9-1D55-F7ECA0432EAC}"/>
              </a:ext>
            </a:extLst>
          </p:cNvPr>
          <p:cNvSpPr txBox="1"/>
          <p:nvPr/>
        </p:nvSpPr>
        <p:spPr>
          <a:xfrm>
            <a:off x="792000" y="1294187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2F5FE82-94C6-893F-5AF7-7FB6E15DCF8A}"/>
              </a:ext>
            </a:extLst>
          </p:cNvPr>
          <p:cNvSpPr/>
          <p:nvPr/>
        </p:nvSpPr>
        <p:spPr>
          <a:xfrm>
            <a:off x="2267050" y="4469009"/>
            <a:ext cx="2053489" cy="6617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8">
            <a:extLst>
              <a:ext uri="{FF2B5EF4-FFF2-40B4-BE49-F238E27FC236}">
                <a16:creationId xmlns:a16="http://schemas.microsoft.com/office/drawing/2014/main" id="{26D35BF7-8AAE-4F8D-A151-2CC0B4385253}"/>
              </a:ext>
            </a:extLst>
          </p:cNvPr>
          <p:cNvSpPr/>
          <p:nvPr/>
        </p:nvSpPr>
        <p:spPr>
          <a:xfrm>
            <a:off x="2274670" y="3051689"/>
            <a:ext cx="2053489" cy="5144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28">
            <a:extLst>
              <a:ext uri="{FF2B5EF4-FFF2-40B4-BE49-F238E27FC236}">
                <a16:creationId xmlns:a16="http://schemas.microsoft.com/office/drawing/2014/main" id="{9CCD98EE-DD91-4CD9-944C-F1A9C68D09D9}"/>
              </a:ext>
            </a:extLst>
          </p:cNvPr>
          <p:cNvSpPr/>
          <p:nvPr/>
        </p:nvSpPr>
        <p:spPr>
          <a:xfrm>
            <a:off x="2274670" y="1352430"/>
            <a:ext cx="2053489" cy="455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28">
            <a:extLst>
              <a:ext uri="{FF2B5EF4-FFF2-40B4-BE49-F238E27FC236}">
                <a16:creationId xmlns:a16="http://schemas.microsoft.com/office/drawing/2014/main" id="{9A914F1E-2723-4654-97E5-F2A415B40C35}"/>
              </a:ext>
            </a:extLst>
          </p:cNvPr>
          <p:cNvSpPr/>
          <p:nvPr/>
        </p:nvSpPr>
        <p:spPr>
          <a:xfrm>
            <a:off x="8187790" y="1504830"/>
            <a:ext cx="2053489" cy="455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28">
            <a:extLst>
              <a:ext uri="{FF2B5EF4-FFF2-40B4-BE49-F238E27FC236}">
                <a16:creationId xmlns:a16="http://schemas.microsoft.com/office/drawing/2014/main" id="{85F7756E-B8B0-4E40-A281-6695BBBA3F35}"/>
              </a:ext>
            </a:extLst>
          </p:cNvPr>
          <p:cNvSpPr/>
          <p:nvPr/>
        </p:nvSpPr>
        <p:spPr>
          <a:xfrm>
            <a:off x="8187790" y="2499901"/>
            <a:ext cx="2053489" cy="45582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287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-3791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5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3095BDC-5D14-7321-B26F-CDD68A3CF8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2275" y="89665"/>
            <a:ext cx="5230368" cy="2075688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A04317A6-1F39-40B4-9B5E-1EB6B206D6D0}"/>
              </a:ext>
            </a:extLst>
          </p:cNvPr>
          <p:cNvSpPr txBox="1"/>
          <p:nvPr/>
        </p:nvSpPr>
        <p:spPr>
          <a:xfrm>
            <a:off x="7819476" y="1425177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E75D9112-1C75-4373-FF2E-2513045758C6}"/>
              </a:ext>
            </a:extLst>
          </p:cNvPr>
          <p:cNvSpPr/>
          <p:nvPr/>
        </p:nvSpPr>
        <p:spPr>
          <a:xfrm>
            <a:off x="4273144" y="1220252"/>
            <a:ext cx="3525463" cy="77918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4225FE1-B7F9-44CB-8E3D-701832BA9C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5799" y="2259589"/>
            <a:ext cx="5262953" cy="245477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3CC6BF2-57DB-8F80-6C0D-A98854C3BB2D}"/>
              </a:ext>
            </a:extLst>
          </p:cNvPr>
          <p:cNvSpPr txBox="1"/>
          <p:nvPr/>
        </p:nvSpPr>
        <p:spPr>
          <a:xfrm>
            <a:off x="7819200" y="256771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52F5DFB7-0617-7588-B939-C68885201674}"/>
              </a:ext>
            </a:extLst>
          </p:cNvPr>
          <p:cNvSpPr/>
          <p:nvPr/>
        </p:nvSpPr>
        <p:spPr>
          <a:xfrm>
            <a:off x="4262649" y="2335728"/>
            <a:ext cx="3535957" cy="6308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ED13AC2-5B3C-434C-601C-7E52ECC9E85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72"/>
          <a:stretch/>
        </p:blipFill>
        <p:spPr>
          <a:xfrm>
            <a:off x="3611615" y="4841146"/>
            <a:ext cx="4562856" cy="162744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88142F1C-0610-4B4E-C314-CA7C1FA68EA5}"/>
              </a:ext>
            </a:extLst>
          </p:cNvPr>
          <p:cNvSpPr txBox="1"/>
          <p:nvPr/>
        </p:nvSpPr>
        <p:spPr>
          <a:xfrm>
            <a:off x="8174471" y="598617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418E18A1-4ACE-76DD-F641-B15E2607253F}"/>
              </a:ext>
            </a:extLst>
          </p:cNvPr>
          <p:cNvSpPr/>
          <p:nvPr/>
        </p:nvSpPr>
        <p:spPr>
          <a:xfrm>
            <a:off x="4318692" y="5883442"/>
            <a:ext cx="3409900" cy="4933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A0079F5-3D4E-8BE9-1D55-F7ECA0432EAC}"/>
              </a:ext>
            </a:extLst>
          </p:cNvPr>
          <p:cNvSpPr txBox="1"/>
          <p:nvPr/>
        </p:nvSpPr>
        <p:spPr>
          <a:xfrm>
            <a:off x="2841091" y="1425177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D4B07E8-EFC5-A5A4-7631-B5E104AF64C1}"/>
              </a:ext>
            </a:extLst>
          </p:cNvPr>
          <p:cNvSpPr txBox="1"/>
          <p:nvPr/>
        </p:nvSpPr>
        <p:spPr>
          <a:xfrm>
            <a:off x="2842560" y="2346046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HO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D4B2376-1C39-3215-85FA-717D04A823A3}"/>
              </a:ext>
            </a:extLst>
          </p:cNvPr>
          <p:cNvSpPr txBox="1"/>
          <p:nvPr/>
        </p:nvSpPr>
        <p:spPr>
          <a:xfrm>
            <a:off x="2842560" y="5986178"/>
            <a:ext cx="1296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27092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3C7FBB-A13B-3FAC-B89B-7951C70377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753C493F-A97A-4102-674C-0462BBB275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6742" y="525706"/>
            <a:ext cx="4618483" cy="1135998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EB8440EC-2BD9-D1FA-FA93-7C19958105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1452" y="3831461"/>
            <a:ext cx="4901633" cy="240492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C523C31-C29A-2093-BD81-FBCAB757D4FC}"/>
              </a:ext>
            </a:extLst>
          </p:cNvPr>
          <p:cNvSpPr txBox="1"/>
          <p:nvPr/>
        </p:nvSpPr>
        <p:spPr>
          <a:xfrm>
            <a:off x="0" y="-3791"/>
            <a:ext cx="27715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5D (continued)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6790576-3BBF-45C7-851F-20C1EC4AE108}"/>
              </a:ext>
            </a:extLst>
          </p:cNvPr>
          <p:cNvSpPr txBox="1"/>
          <p:nvPr/>
        </p:nvSpPr>
        <p:spPr>
          <a:xfrm>
            <a:off x="2340000" y="964800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SGK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526EB54-8D46-E4B6-CC53-308807AEFFE5}"/>
              </a:ext>
            </a:extLst>
          </p:cNvPr>
          <p:cNvSpPr txBox="1"/>
          <p:nvPr/>
        </p:nvSpPr>
        <p:spPr>
          <a:xfrm>
            <a:off x="8434505" y="927777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33C66EF-951D-F5D4-4D4B-E41AFB2BD72D}"/>
              </a:ext>
            </a:extLst>
          </p:cNvPr>
          <p:cNvSpPr txBox="1"/>
          <p:nvPr/>
        </p:nvSpPr>
        <p:spPr>
          <a:xfrm>
            <a:off x="2340000" y="4820400"/>
            <a:ext cx="11994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8843C79-1EA9-B92C-FE57-8E4159D43F98}"/>
              </a:ext>
            </a:extLst>
          </p:cNvPr>
          <p:cNvSpPr txBox="1"/>
          <p:nvPr/>
        </p:nvSpPr>
        <p:spPr>
          <a:xfrm>
            <a:off x="8436420" y="478885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3423F3CD-9A8C-8993-D2D1-2C05DB60A79C}"/>
              </a:ext>
            </a:extLst>
          </p:cNvPr>
          <p:cNvSpPr/>
          <p:nvPr/>
        </p:nvSpPr>
        <p:spPr>
          <a:xfrm>
            <a:off x="4148020" y="895038"/>
            <a:ext cx="3569110" cy="4379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CAA484E-F773-8DD1-E894-6532B7DED73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7266" y="1957385"/>
            <a:ext cx="4867219" cy="143268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A9FD318-A284-73A2-1367-A83922A36BBF}"/>
              </a:ext>
            </a:extLst>
          </p:cNvPr>
          <p:cNvSpPr txBox="1"/>
          <p:nvPr/>
        </p:nvSpPr>
        <p:spPr>
          <a:xfrm>
            <a:off x="8434505" y="2320341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C9869A4-C3E3-42E3-0EC5-B6D276793CAA}"/>
              </a:ext>
            </a:extLst>
          </p:cNvPr>
          <p:cNvSpPr txBox="1"/>
          <p:nvPr/>
        </p:nvSpPr>
        <p:spPr>
          <a:xfrm>
            <a:off x="2341094" y="2090327"/>
            <a:ext cx="129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36">
            <a:extLst>
              <a:ext uri="{FF2B5EF4-FFF2-40B4-BE49-F238E27FC236}">
                <a16:creationId xmlns:a16="http://schemas.microsoft.com/office/drawing/2014/main" id="{520DCF60-1E2B-457B-A19B-4DC6269EE72F}"/>
              </a:ext>
            </a:extLst>
          </p:cNvPr>
          <p:cNvSpPr/>
          <p:nvPr/>
        </p:nvSpPr>
        <p:spPr>
          <a:xfrm>
            <a:off x="4148020" y="2168092"/>
            <a:ext cx="3569110" cy="490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36">
            <a:extLst>
              <a:ext uri="{FF2B5EF4-FFF2-40B4-BE49-F238E27FC236}">
                <a16:creationId xmlns:a16="http://schemas.microsoft.com/office/drawing/2014/main" id="{C307E7DA-EB59-447D-B1A0-066DAEDE6D63}"/>
              </a:ext>
            </a:extLst>
          </p:cNvPr>
          <p:cNvSpPr/>
          <p:nvPr/>
        </p:nvSpPr>
        <p:spPr>
          <a:xfrm>
            <a:off x="4140400" y="4788858"/>
            <a:ext cx="3569110" cy="4379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24693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-1" y="10548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6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1DB57BC1-07AE-345D-A3CB-57FD5FFF92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3535" y="1013519"/>
            <a:ext cx="5111496" cy="196596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78F3BC58-BAF1-225E-BEDE-BE7BA0FF9D46}"/>
              </a:ext>
            </a:extLst>
          </p:cNvPr>
          <p:cNvSpPr txBox="1"/>
          <p:nvPr/>
        </p:nvSpPr>
        <p:spPr>
          <a:xfrm>
            <a:off x="8729353" y="989354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36C05C8-FE4A-AE4C-866E-79A1CD4378A7}"/>
              </a:ext>
            </a:extLst>
          </p:cNvPr>
          <p:cNvSpPr txBox="1"/>
          <p:nvPr/>
        </p:nvSpPr>
        <p:spPr>
          <a:xfrm>
            <a:off x="3656251" y="856674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HO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B534EAE1-38E7-19BB-9B59-A594D688514E}"/>
              </a:ext>
            </a:extLst>
          </p:cNvPr>
          <p:cNvSpPr/>
          <p:nvPr/>
        </p:nvSpPr>
        <p:spPr>
          <a:xfrm>
            <a:off x="4423818" y="1013519"/>
            <a:ext cx="3883610" cy="87483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1DDD55D-486B-74FA-F843-C4E40B5EC6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3535" y="3429000"/>
            <a:ext cx="4993592" cy="105024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27C60836-6A49-C21F-BCDC-1C7ED1F57644}"/>
              </a:ext>
            </a:extLst>
          </p:cNvPr>
          <p:cNvSpPr/>
          <p:nvPr/>
        </p:nvSpPr>
        <p:spPr>
          <a:xfrm>
            <a:off x="4397478" y="3429000"/>
            <a:ext cx="3984522" cy="87884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233A654-BFDE-E362-E947-97DF8CD66BB5}"/>
              </a:ext>
            </a:extLst>
          </p:cNvPr>
          <p:cNvSpPr txBox="1"/>
          <p:nvPr/>
        </p:nvSpPr>
        <p:spPr>
          <a:xfrm>
            <a:off x="8777127" y="3679312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1623CD9-7DE2-4776-C261-915B10EC5625}"/>
              </a:ext>
            </a:extLst>
          </p:cNvPr>
          <p:cNvSpPr txBox="1"/>
          <p:nvPr/>
        </p:nvSpPr>
        <p:spPr>
          <a:xfrm>
            <a:off x="3101118" y="3693856"/>
            <a:ext cx="1296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99864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EAD95B-E41E-01CD-8AD1-3E352CAD9F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>
            <a:extLst>
              <a:ext uri="{FF2B5EF4-FFF2-40B4-BE49-F238E27FC236}">
                <a16:creationId xmlns:a16="http://schemas.microsoft.com/office/drawing/2014/main" id="{12670692-580E-EFCF-C4BA-1DAF00D78E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2092" y="1310012"/>
            <a:ext cx="4643119" cy="116992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0781C3C-5BC7-DA1F-8B05-A31C426D1B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1103" y="2430018"/>
            <a:ext cx="4938557" cy="156159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0DB6E94E-502E-AB39-4193-8E33D33BB3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7529" y="31849"/>
            <a:ext cx="4643120" cy="112255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29096A8-91CE-E654-B353-1C0297E9B6CB}"/>
              </a:ext>
            </a:extLst>
          </p:cNvPr>
          <p:cNvSpPr txBox="1"/>
          <p:nvPr/>
        </p:nvSpPr>
        <p:spPr>
          <a:xfrm>
            <a:off x="-1" y="10548"/>
            <a:ext cx="26619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6C (continued)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3F0DE50-CDD3-A91F-8F37-3DDCBC8177A7}"/>
              </a:ext>
            </a:extLst>
          </p:cNvPr>
          <p:cNvSpPr txBox="1"/>
          <p:nvPr/>
        </p:nvSpPr>
        <p:spPr>
          <a:xfrm>
            <a:off x="2793600" y="1892564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BA5D6F3-3D2F-B16E-C8F3-AC6A0A17090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12743">
            <a:off x="3250430" y="4017395"/>
            <a:ext cx="6178418" cy="153518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B9AF7D09-B04E-E849-CECA-DE869D4D99BD}"/>
              </a:ext>
            </a:extLst>
          </p:cNvPr>
          <p:cNvSpPr txBox="1"/>
          <p:nvPr/>
        </p:nvSpPr>
        <p:spPr>
          <a:xfrm>
            <a:off x="8636400" y="1911457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56A8493-C90D-40EE-BE20-A9BAA6A85E16}"/>
              </a:ext>
            </a:extLst>
          </p:cNvPr>
          <p:cNvSpPr txBox="1"/>
          <p:nvPr/>
        </p:nvSpPr>
        <p:spPr>
          <a:xfrm>
            <a:off x="8636400" y="423850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275724C-62DB-458D-5E8F-8D79CCF4B682}"/>
              </a:ext>
            </a:extLst>
          </p:cNvPr>
          <p:cNvSpPr txBox="1"/>
          <p:nvPr/>
        </p:nvSpPr>
        <p:spPr>
          <a:xfrm>
            <a:off x="2793600" y="657785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SGK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B56CEF7-57E8-C872-3456-09724EE65EA8}"/>
              </a:ext>
            </a:extLst>
          </p:cNvPr>
          <p:cNvSpPr txBox="1"/>
          <p:nvPr/>
        </p:nvSpPr>
        <p:spPr>
          <a:xfrm>
            <a:off x="2793600" y="4586333"/>
            <a:ext cx="129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leaved-Caspas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BE0AC08-08AF-1CB3-1886-B8CD90337EBC}"/>
              </a:ext>
            </a:extLst>
          </p:cNvPr>
          <p:cNvSpPr txBox="1"/>
          <p:nvPr/>
        </p:nvSpPr>
        <p:spPr>
          <a:xfrm>
            <a:off x="8636400" y="4623743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DE35F50-2703-15BE-EC36-FD94A08BDB24}"/>
              </a:ext>
            </a:extLst>
          </p:cNvPr>
          <p:cNvSpPr txBox="1"/>
          <p:nvPr/>
        </p:nvSpPr>
        <p:spPr>
          <a:xfrm>
            <a:off x="2793600" y="2889982"/>
            <a:ext cx="1296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DE365A1-44F2-3F3C-EB89-7B7501A4E303}"/>
              </a:ext>
            </a:extLst>
          </p:cNvPr>
          <p:cNvSpPr txBox="1"/>
          <p:nvPr/>
        </p:nvSpPr>
        <p:spPr>
          <a:xfrm>
            <a:off x="8636400" y="2952879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1F18308B-8F17-9894-29B1-AE84C8E8A580}"/>
              </a:ext>
            </a:extLst>
          </p:cNvPr>
          <p:cNvSpPr/>
          <p:nvPr/>
        </p:nvSpPr>
        <p:spPr>
          <a:xfrm>
            <a:off x="4289649" y="2817935"/>
            <a:ext cx="3975511" cy="59320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3F8830E6-40B5-64DE-E259-F77F684A24AE}"/>
              </a:ext>
            </a:extLst>
          </p:cNvPr>
          <p:cNvSpPr/>
          <p:nvPr/>
        </p:nvSpPr>
        <p:spPr>
          <a:xfrm>
            <a:off x="4297385" y="1743816"/>
            <a:ext cx="3952535" cy="59320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753661D8-A0CF-DB93-FD98-229C555A592F}"/>
              </a:ext>
            </a:extLst>
          </p:cNvPr>
          <p:cNvSpPr/>
          <p:nvPr/>
        </p:nvSpPr>
        <p:spPr>
          <a:xfrm>
            <a:off x="4393967" y="4586333"/>
            <a:ext cx="3883610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39">
            <a:extLst>
              <a:ext uri="{FF2B5EF4-FFF2-40B4-BE49-F238E27FC236}">
                <a16:creationId xmlns:a16="http://schemas.microsoft.com/office/drawing/2014/main" id="{5B2D9066-325E-40FD-8332-CD7E8494B0DA}"/>
              </a:ext>
            </a:extLst>
          </p:cNvPr>
          <p:cNvSpPr/>
          <p:nvPr/>
        </p:nvSpPr>
        <p:spPr>
          <a:xfrm>
            <a:off x="4289649" y="457150"/>
            <a:ext cx="3952535" cy="44659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71179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861" y="53281"/>
            <a:ext cx="1296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Fig. 6E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20552" y="3536712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SGK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078526" y="3552101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20700" y="1983002"/>
            <a:ext cx="984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9C1BF33-DFE2-AC39-C109-BF56880F5E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4358" y="1104678"/>
            <a:ext cx="2318246" cy="1514131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52194FC8-96AB-571F-7363-37891E645D5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75625">
            <a:off x="1110312" y="3259444"/>
            <a:ext cx="1901952" cy="2093976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CF3A7FC3-5D7D-8DC9-9EEC-46CF5B2E9DB1}"/>
              </a:ext>
            </a:extLst>
          </p:cNvPr>
          <p:cNvSpPr/>
          <p:nvPr/>
        </p:nvSpPr>
        <p:spPr>
          <a:xfrm>
            <a:off x="1565126" y="3470153"/>
            <a:ext cx="1212968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078526" y="2101168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1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35">
            <a:extLst>
              <a:ext uri="{FF2B5EF4-FFF2-40B4-BE49-F238E27FC236}">
                <a16:creationId xmlns:a16="http://schemas.microsoft.com/office/drawing/2014/main" id="{E842377F-7CC3-479A-A37F-4D9FA8F5610C}"/>
              </a:ext>
            </a:extLst>
          </p:cNvPr>
          <p:cNvSpPr/>
          <p:nvPr/>
        </p:nvSpPr>
        <p:spPr>
          <a:xfrm>
            <a:off x="1588247" y="1927120"/>
            <a:ext cx="1212968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2">
            <a:extLst>
              <a:ext uri="{FF2B5EF4-FFF2-40B4-BE49-F238E27FC236}">
                <a16:creationId xmlns:a16="http://schemas.microsoft.com/office/drawing/2014/main" id="{60328E28-252B-47B8-BA2B-494EDF54D959}"/>
              </a:ext>
            </a:extLst>
          </p:cNvPr>
          <p:cNvSpPr txBox="1"/>
          <p:nvPr/>
        </p:nvSpPr>
        <p:spPr>
          <a:xfrm>
            <a:off x="10023909" y="1334681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25">
            <a:extLst>
              <a:ext uri="{FF2B5EF4-FFF2-40B4-BE49-F238E27FC236}">
                <a16:creationId xmlns:a16="http://schemas.microsoft.com/office/drawing/2014/main" id="{BD2E0ABB-375D-4829-BC55-9255A1828A4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5351" y="887676"/>
            <a:ext cx="3828558" cy="1708819"/>
          </a:xfrm>
          <a:prstGeom prst="rect">
            <a:avLst/>
          </a:prstGeom>
        </p:spPr>
      </p:pic>
      <p:sp>
        <p:nvSpPr>
          <p:cNvPr id="21" name="文本框 28">
            <a:extLst>
              <a:ext uri="{FF2B5EF4-FFF2-40B4-BE49-F238E27FC236}">
                <a16:creationId xmlns:a16="http://schemas.microsoft.com/office/drawing/2014/main" id="{E6D9C235-5207-46BD-9F69-E652443175D7}"/>
              </a:ext>
            </a:extLst>
          </p:cNvPr>
          <p:cNvSpPr txBox="1"/>
          <p:nvPr/>
        </p:nvSpPr>
        <p:spPr>
          <a:xfrm>
            <a:off x="5003770" y="1108852"/>
            <a:ext cx="129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Cleaved-Caspas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35">
            <a:extLst>
              <a:ext uri="{FF2B5EF4-FFF2-40B4-BE49-F238E27FC236}">
                <a16:creationId xmlns:a16="http://schemas.microsoft.com/office/drawing/2014/main" id="{6E95886D-47AD-4D1D-A163-EA29E4DBFE3B}"/>
              </a:ext>
            </a:extLst>
          </p:cNvPr>
          <p:cNvSpPr/>
          <p:nvPr/>
        </p:nvSpPr>
        <p:spPr>
          <a:xfrm>
            <a:off x="6731486" y="1252733"/>
            <a:ext cx="1212968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13">
            <a:extLst>
              <a:ext uri="{FF2B5EF4-FFF2-40B4-BE49-F238E27FC236}">
                <a16:creationId xmlns:a16="http://schemas.microsoft.com/office/drawing/2014/main" id="{A2DC3613-0594-478C-8DC7-69344EA79FD3}"/>
              </a:ext>
            </a:extLst>
          </p:cNvPr>
          <p:cNvSpPr txBox="1"/>
          <p:nvPr/>
        </p:nvSpPr>
        <p:spPr>
          <a:xfrm>
            <a:off x="8615837" y="3986045"/>
            <a:ext cx="984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5">
            <a:extLst>
              <a:ext uri="{FF2B5EF4-FFF2-40B4-BE49-F238E27FC236}">
                <a16:creationId xmlns:a16="http://schemas.microsoft.com/office/drawing/2014/main" id="{56044C27-A8C2-41F1-BB12-437E7B2A40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4490" y="3009198"/>
            <a:ext cx="2361347" cy="1536192"/>
          </a:xfrm>
          <a:prstGeom prst="rect">
            <a:avLst/>
          </a:prstGeom>
        </p:spPr>
      </p:pic>
      <p:sp>
        <p:nvSpPr>
          <p:cNvPr id="28" name="文本框 9">
            <a:extLst>
              <a:ext uri="{FF2B5EF4-FFF2-40B4-BE49-F238E27FC236}">
                <a16:creationId xmlns:a16="http://schemas.microsoft.com/office/drawing/2014/main" id="{8DCF4990-A6E9-4C80-8FBF-C12ECD709CCA}"/>
              </a:ext>
            </a:extLst>
          </p:cNvPr>
          <p:cNvSpPr txBox="1"/>
          <p:nvPr/>
        </p:nvSpPr>
        <p:spPr>
          <a:xfrm>
            <a:off x="5003770" y="4056153"/>
            <a:ext cx="1371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35">
            <a:extLst>
              <a:ext uri="{FF2B5EF4-FFF2-40B4-BE49-F238E27FC236}">
                <a16:creationId xmlns:a16="http://schemas.microsoft.com/office/drawing/2014/main" id="{7232F27B-2806-4F52-88F8-E3BA2191E8C5}"/>
              </a:ext>
            </a:extLst>
          </p:cNvPr>
          <p:cNvSpPr/>
          <p:nvPr/>
        </p:nvSpPr>
        <p:spPr>
          <a:xfrm>
            <a:off x="7020003" y="3892257"/>
            <a:ext cx="1212968" cy="5024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3566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84</TotalTime>
  <Words>209</Words>
  <Application>Microsoft Office PowerPoint</Application>
  <PresentationFormat>宽屏</PresentationFormat>
  <Paragraphs>115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岸彪 吴</dc:creator>
  <cp:lastModifiedBy>岸彪 吴</cp:lastModifiedBy>
  <cp:revision>22</cp:revision>
  <dcterms:created xsi:type="dcterms:W3CDTF">2024-06-14T07:33:09Z</dcterms:created>
  <dcterms:modified xsi:type="dcterms:W3CDTF">2025-01-04T13:59:40Z</dcterms:modified>
</cp:coreProperties>
</file>